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602DD3-176A-4A83-9279-A840CAE9B7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16290-5805-431C-8605-A1A74D6A6F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7B26B4-5DA2-4CC4-A261-CB3B7E3BF0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6B2A7-7A36-4EDF-9D39-C3DAB79FBD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4D282-8449-485A-85C6-CC78F6DB72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7B019-0758-4F4E-AC70-959644F114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14942D-19EA-43AA-B792-6C5E519FAC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2425F-92E8-4D62-A01D-3D344B8CFE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83817-562E-4BB9-B8D2-A10F56EFB5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EF439-C1B5-4550-9FD7-A3637CB121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7E7AB-7506-41DC-AD0C-AA4FAB7B59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F1C87-17F7-419C-84E2-E9DE6A7912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03293D-4D65-4A9C-85FC-CDAF9D42748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762120" y="381240"/>
            <a:ext cx="670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Table S1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Total Cell Death (TD) as determined by Trypan blue exclus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9"/>
          <p:cNvSpPr/>
          <p:nvPr/>
        </p:nvSpPr>
        <p:spPr>
          <a:xfrm>
            <a:off x="500040" y="3803760"/>
            <a:ext cx="573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B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AML blasts ex vivo: Total cell death by cell membrane permeabilit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0"/>
          <p:cNvSpPr/>
          <p:nvPr/>
        </p:nvSpPr>
        <p:spPr>
          <a:xfrm>
            <a:off x="736200" y="914400"/>
            <a:ext cx="6360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A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Normal Bone Marrow (BM): Total cell death by cell membrane permeabilit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228600" y="4191120"/>
          <a:ext cx="8454960" cy="1600200"/>
        </p:xfrm>
        <a:graphic>
          <a:graphicData uri="http://schemas.openxmlformats.org/drawingml/2006/table">
            <a:tbl>
              <a:tblPr/>
              <a:tblGrid>
                <a:gridCol w="1684440"/>
                <a:gridCol w="558720"/>
                <a:gridCol w="606240"/>
                <a:gridCol w="605160"/>
                <a:gridCol w="581040"/>
                <a:gridCol w="604800"/>
                <a:gridCol w="606240"/>
                <a:gridCol w="857160"/>
                <a:gridCol w="858960"/>
                <a:gridCol w="635040"/>
                <a:gridCol w="857160"/>
              </a:tblGrid>
              <a:tr h="19980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tient 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tient 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tient 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tient 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tient 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tient 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ML-ex vivo cell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s Contr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s AraC alo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.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2(100nM)+CA(10uM)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.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3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-C-72 hr-Control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.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-C-72 hr-CA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.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7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-C-72 hr-D2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.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6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-C-72 hr-D2+CA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8.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.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527040" y="1371600"/>
          <a:ext cx="7112160" cy="1523880"/>
        </p:xfrm>
        <a:graphic>
          <a:graphicData uri="http://schemas.openxmlformats.org/drawingml/2006/table">
            <a:tbl>
              <a:tblPr/>
              <a:tblGrid>
                <a:gridCol w="1727280"/>
                <a:gridCol w="609480"/>
                <a:gridCol w="609480"/>
                <a:gridCol w="609840"/>
                <a:gridCol w="609480"/>
                <a:gridCol w="609480"/>
                <a:gridCol w="609840"/>
                <a:gridCol w="863640"/>
                <a:gridCol w="863640"/>
              </a:tblGrid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 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 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 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 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ver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rmal BM cell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s Contr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s AraC alo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.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2(100nM)+CA(10uM)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.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.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5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-C-72 hr-Control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.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-C-72 hr-CA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.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-C-72 hr-D2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.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-C-72 hr-D2+CA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.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17T16:24:02Z</dcterms:created>
  <dc:creator>UmdNJ</dc:creator>
  <dc:description/>
  <dc:language>en-US</dc:language>
  <cp:lastModifiedBy>Wang, Xuening</cp:lastModifiedBy>
  <dcterms:modified xsi:type="dcterms:W3CDTF">2016-03-21T23:26:15Z</dcterms:modified>
  <cp:revision>13</cp:revision>
  <dc:subject/>
  <dc:title>Slide 1</dc:title>
</cp:coreProperties>
</file>